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ABD39A-80DF-402D-91AA-F39839ADB83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AB04A8-4EB6-4AC5-A288-A6726BEA63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83146A-30DB-4EEB-B94E-706053230F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FE95CE-9D53-428E-9509-191632AB156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3603FD-F5A7-42F9-BA31-536A157578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B700B2-D087-4CF2-88CA-E44A20420D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9A2E95-DBBC-4D96-9426-7DA68B2C82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FE1D75-85E5-401A-80B6-003FDFCA7C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65FC1C-6934-4D0E-825E-F3161A11160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7D2C74-1421-4FE4-8F8D-BF9D4DBD21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4869C4-765A-4254-B78C-B5DD40F785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DCA9CE-BEB0-4282-BF87-F80228F6AD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F330C07-3F40-48C2-8BEA-45699C20F6FE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903320" y="795240"/>
          <a:ext cx="3632400" cy="5396040"/>
        </p:xfrm>
        <a:graphic>
          <a:graphicData uri="http://schemas.openxmlformats.org/drawingml/2006/table">
            <a:tbl>
              <a:tblPr/>
              <a:tblGrid>
                <a:gridCol w="550800"/>
                <a:gridCol w="617760"/>
                <a:gridCol w="841320"/>
                <a:gridCol w="855720"/>
                <a:gridCol w="766800"/>
              </a:tblGrid>
              <a:tr h="28728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I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nam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-inflorescence-inflorescenc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flower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inflorescenc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458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0606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60a0a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31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63547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0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a709f"/>
                    </a:solidFill>
                  </a:tcPr>
                </a:tc>
              </a:tr>
              <a:tr h="11088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31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0606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31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12d3c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3f56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31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3a4f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32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c597d"/>
                    </a:solidFill>
                  </a:tcPr>
                </a:tc>
              </a:tr>
              <a:tr h="11088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32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1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3a50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32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1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85273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32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b3d54"/>
                    </a:solidFill>
                  </a:tcPr>
                </a:tc>
              </a:tr>
              <a:tr h="11088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33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80404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33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44b69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14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1088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44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b577b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45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20909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09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K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3f57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088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597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LECRK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64f6e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06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WI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80808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094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99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RR XI-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3a4f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165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RR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33142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84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EKK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8384d"/>
                    </a:solidFill>
                  </a:tcPr>
                </a:tc>
              </a:tr>
              <a:tr h="11088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16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KK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a3c52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35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KK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44c6a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86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KS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33040"/>
                    </a:solidFill>
                  </a:tcPr>
                </a:tc>
              </a:tr>
              <a:tr h="11088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456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PK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34b68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47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PK1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53345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382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5K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2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1088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18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XC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33040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26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LP2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40505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056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LP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63649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088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231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LP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e0a0a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231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LP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6e0808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288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LP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e5c81"/>
                    </a:solidFill>
                  </a:tcPr>
                </a:tc>
              </a:tr>
              <a:tr h="11088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39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LP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8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e5c82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92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PK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374b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24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24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d415a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97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97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12e3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094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027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027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33041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088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21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21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66a96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220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220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20a0a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470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470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53447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03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03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374a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088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15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152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33041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a3c53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8394e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390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390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1f2a38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8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b587b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485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485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b3e55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088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96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96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70606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634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634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4320" rIns="4320" tIns="43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4320" marR="43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3a4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6257880" y="800280"/>
          <a:ext cx="3454560" cy="4430520"/>
        </p:xfrm>
        <a:graphic>
          <a:graphicData uri="http://schemas.openxmlformats.org/drawingml/2006/table">
            <a:tbl>
              <a:tblPr/>
              <a:tblGrid>
                <a:gridCol w="596880"/>
                <a:gridCol w="576360"/>
                <a:gridCol w="790560"/>
                <a:gridCol w="749160"/>
                <a:gridCol w="741600"/>
              </a:tblGrid>
              <a:tr h="2872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I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nam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-inflorescence-inflorescenc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flowering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inflorescence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126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70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BCB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10606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08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223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OX1a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34b68"/>
                    </a:solidFill>
                  </a:tcPr>
                </a:tc>
              </a:tr>
              <a:tr h="11772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323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OX1d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26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33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DOA1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1124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00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CAT-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26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509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CS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b3d54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24865"/>
                    </a:solidFill>
                  </a:tcPr>
                </a:tc>
              </a:tr>
              <a:tr h="1108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040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8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00707"/>
                    </a:solidFill>
                  </a:tcPr>
                </a:tc>
              </a:tr>
              <a:tr h="1126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616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F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50707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45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IC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b577a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3077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D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80303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26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30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LDP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e0707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012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IR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04560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26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239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SP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0606"/>
                    </a:solidFill>
                  </a:tcPr>
                </a:tc>
              </a:tr>
              <a:tr h="1108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25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SP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0606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374a"/>
                    </a:solidFill>
                  </a:tcPr>
                </a:tc>
              </a:tr>
              <a:tr h="1126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462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TERF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e5c82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70505"/>
                    </a:solidFill>
                  </a:tcPr>
                </a:tc>
              </a:tr>
              <a:tr h="11124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79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tHsc70-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10707"/>
                    </a:solidFill>
                  </a:tcPr>
                </a:tc>
              </a:tr>
              <a:tr h="11124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08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GOX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34a68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26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387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DH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5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98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EN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43244"/>
                    </a:solidFill>
                  </a:tcPr>
                </a:tc>
              </a:tr>
              <a:tr h="1126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56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OXY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4e6c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108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13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AMT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0505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1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1126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12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AUR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4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f0707"/>
                    </a:solidFill>
                  </a:tcPr>
                </a:tc>
              </a:tr>
              <a:tr h="11124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6069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AUR5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20707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43243"/>
                    </a:solidFill>
                  </a:tcPr>
                </a:tc>
              </a:tr>
              <a:tr h="11124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61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AUR7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3a4f"/>
                    </a:solidFill>
                  </a:tcPr>
                </a:tc>
              </a:tr>
              <a:tr h="1126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0376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OT1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6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63649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124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34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P-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e0101"/>
                    </a:solidFill>
                  </a:tcPr>
                </a:tc>
              </a:tr>
              <a:tr h="1126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73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IP2;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33142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a3c53"/>
                    </a:solidFill>
                  </a:tcPr>
                </a:tc>
              </a:tr>
              <a:tr h="1108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14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14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f5d84"/>
                    </a:solidFill>
                  </a:tcPr>
                </a:tc>
              </a:tr>
              <a:tr h="1126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38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384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82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66995"/>
                    </a:solidFill>
                  </a:tcPr>
                </a:tc>
              </a:tr>
              <a:tr h="11124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14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141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1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75171"/>
                    </a:solidFill>
                  </a:tcPr>
                </a:tc>
              </a:tr>
              <a:tr h="11124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17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17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3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d0707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26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65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65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e425b"/>
                    </a:solidFill>
                  </a:tcPr>
                </a:tc>
              </a:tr>
              <a:tr h="1108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431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431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85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76b98"/>
                    </a:solidFill>
                  </a:tcPr>
                </a:tc>
              </a:tr>
              <a:tr h="11304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434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4345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b0707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  <a:tr h="1108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29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297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7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c0505"/>
                    </a:solidFill>
                  </a:tcPr>
                </a:tc>
              </a:tr>
              <a:tr h="11268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38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388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9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8394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384c"/>
                    </a:solidFill>
                  </a:tcPr>
                </a:tc>
              </a:tr>
              <a:tr h="111240"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41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i="1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413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8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b0707"/>
                    </a:solidFill>
                  </a:tcPr>
                </a:tc>
                <a:tc>
                  <a:txBody>
                    <a:bodyPr lIns="5040" rIns="5040" tIns="504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7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7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5040" marR="504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d0d0d"/>
                    </a:solidFill>
                  </a:tcPr>
                </a:tc>
              </a:tr>
            </a:tbl>
          </a:graphicData>
        </a:graphic>
      </p:graphicFrame>
      <p:grpSp>
        <p:nvGrpSpPr>
          <p:cNvPr id="43" name="Gruppieren 1"/>
          <p:cNvGrpSpPr/>
          <p:nvPr/>
        </p:nvGrpSpPr>
        <p:grpSpPr>
          <a:xfrm>
            <a:off x="6240600" y="5297400"/>
            <a:ext cx="2119320" cy="399600"/>
            <a:chOff x="6240600" y="5297400"/>
            <a:chExt cx="2119320" cy="399600"/>
          </a:xfrm>
        </p:grpSpPr>
        <p:grpSp>
          <p:nvGrpSpPr>
            <p:cNvPr id="44" name="Gruppieren 2"/>
            <p:cNvGrpSpPr/>
            <p:nvPr/>
          </p:nvGrpSpPr>
          <p:grpSpPr>
            <a:xfrm>
              <a:off x="6317280" y="5297400"/>
              <a:ext cx="2042640" cy="215640"/>
              <a:chOff x="6317280" y="5297400"/>
              <a:chExt cx="2042640" cy="215640"/>
            </a:xfrm>
          </p:grpSpPr>
          <p:pic>
            <p:nvPicPr>
              <p:cNvPr id="45" name="Grafik 4" descr=""/>
              <p:cNvPicPr/>
              <p:nvPr/>
            </p:nvPicPr>
            <p:blipFill>
              <a:blip r:embed="rId1"/>
              <a:stretch/>
            </p:blipFill>
            <p:spPr>
              <a:xfrm>
                <a:off x="6317280" y="5346000"/>
                <a:ext cx="1096920" cy="158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6" name="Textfeld 2"/>
              <p:cNvSpPr/>
              <p:nvPr/>
            </p:nvSpPr>
            <p:spPr>
              <a:xfrm>
                <a:off x="7364880" y="5297400"/>
                <a:ext cx="9950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og</a:t>
                </a: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fold chang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47" name="Textfeld 2"/>
            <p:cNvSpPr/>
            <p:nvPr/>
          </p:nvSpPr>
          <p:spPr>
            <a:xfrm>
              <a:off x="7232760" y="5420520"/>
              <a:ext cx="2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feld 7"/>
            <p:cNvSpPr/>
            <p:nvPr/>
          </p:nvSpPr>
          <p:spPr>
            <a:xfrm>
              <a:off x="6240600" y="5408280"/>
              <a:ext cx="2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9" name="Gruppieren 2"/>
          <p:cNvGrpSpPr/>
          <p:nvPr/>
        </p:nvGrpSpPr>
        <p:grpSpPr>
          <a:xfrm>
            <a:off x="1849320" y="6229440"/>
            <a:ext cx="2152800" cy="390240"/>
            <a:chOff x="1849320" y="6229440"/>
            <a:chExt cx="2152800" cy="390240"/>
          </a:xfrm>
        </p:grpSpPr>
        <p:grpSp>
          <p:nvGrpSpPr>
            <p:cNvPr id="50" name="Gruppieren 2"/>
            <p:cNvGrpSpPr/>
            <p:nvPr/>
          </p:nvGrpSpPr>
          <p:grpSpPr>
            <a:xfrm>
              <a:off x="1936800" y="6229440"/>
              <a:ext cx="2065320" cy="215640"/>
              <a:chOff x="1936800" y="6229440"/>
              <a:chExt cx="2065320" cy="215640"/>
            </a:xfrm>
          </p:grpSpPr>
          <p:pic>
            <p:nvPicPr>
              <p:cNvPr id="51" name="Grafik 4" descr=""/>
              <p:cNvPicPr/>
              <p:nvPr/>
            </p:nvPicPr>
            <p:blipFill>
              <a:blip r:embed="rId2"/>
              <a:stretch/>
            </p:blipFill>
            <p:spPr>
              <a:xfrm>
                <a:off x="1936800" y="6260760"/>
                <a:ext cx="1116720" cy="17208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2" name="Textfeld 2"/>
              <p:cNvSpPr/>
              <p:nvPr/>
            </p:nvSpPr>
            <p:spPr>
              <a:xfrm>
                <a:off x="3006360" y="6229440"/>
                <a:ext cx="995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og</a:t>
                </a: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fold chang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3" name="Textfeld 2"/>
            <p:cNvSpPr/>
            <p:nvPr/>
          </p:nvSpPr>
          <p:spPr>
            <a:xfrm>
              <a:off x="2882880" y="6343200"/>
              <a:ext cx="2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feld 7"/>
            <p:cNvSpPr/>
            <p:nvPr/>
          </p:nvSpPr>
          <p:spPr>
            <a:xfrm>
              <a:off x="1849320" y="6330960"/>
              <a:ext cx="2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5" name="Textfeld 4"/>
          <p:cNvSpPr/>
          <p:nvPr/>
        </p:nvSpPr>
        <p:spPr>
          <a:xfrm>
            <a:off x="222120" y="139680"/>
            <a:ext cx="1252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Fig. S6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feld 6"/>
          <p:cNvSpPr/>
          <p:nvPr/>
        </p:nvSpPr>
        <p:spPr>
          <a:xfrm>
            <a:off x="2009880" y="181080"/>
            <a:ext cx="3344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enes involved in cellular signaling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feld 19"/>
          <p:cNvSpPr/>
          <p:nvPr/>
        </p:nvSpPr>
        <p:spPr>
          <a:xfrm>
            <a:off x="6281640" y="168120"/>
            <a:ext cx="3345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genes involved in mitochondrial perturb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3-04T16:57:07Z</dcterms:created>
  <dc:creator>Hossein</dc:creator>
  <dc:description/>
  <dc:language>en-US</dc:language>
  <cp:lastModifiedBy>Hossein</cp:lastModifiedBy>
  <dcterms:modified xsi:type="dcterms:W3CDTF">2020-03-20T15:34:16Z</dcterms:modified>
  <cp:revision>9</cp:revision>
  <dc:subject/>
  <dc:title>PowerPoint-Präsentation</dc:title>
</cp:coreProperties>
</file>